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897"/>
  </p:normalViewPr>
  <p:slideViewPr>
    <p:cSldViewPr snapToGrid="0">
      <p:cViewPr varScale="1">
        <p:scale>
          <a:sx n="98" d="100"/>
          <a:sy n="98" d="100"/>
        </p:scale>
        <p:origin x="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doughnutChart>
        <c:varyColors val="1"/>
        <c:ser>
          <c:idx val="0"/>
          <c:order val="0"/>
          <c:tx>
            <c:strRef>
              <c:f>'Pie chart serotype distribution'!$I$18</c:f>
              <c:strCache>
                <c:ptCount val="1"/>
                <c:pt idx="0">
                  <c:v>Southwest Sumba</c:v>
                </c:pt>
              </c:strCache>
            </c:strRef>
          </c:tx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81F-0549-B8A3-021E12ED3EE6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81F-0549-B8A3-021E12ED3EE6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81F-0549-B8A3-021E12ED3EE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Pie chart serotype distribution'!$J$17:$L$17</c:f>
              <c:strCache>
                <c:ptCount val="3"/>
                <c:pt idx="0">
                  <c:v>Vaccine Serotypes</c:v>
                </c:pt>
                <c:pt idx="1">
                  <c:v>Non-vaccine Serotypes</c:v>
                </c:pt>
                <c:pt idx="2">
                  <c:v>Nontypeable</c:v>
                </c:pt>
              </c:strCache>
            </c:strRef>
          </c:cat>
          <c:val>
            <c:numRef>
              <c:f>'Pie chart serotype distribution'!$J$18:$L$18</c:f>
              <c:numCache>
                <c:formatCode>0.0%</c:formatCode>
                <c:ptCount val="3"/>
                <c:pt idx="0">
                  <c:v>0.57142857142857195</c:v>
                </c:pt>
                <c:pt idx="1">
                  <c:v>0.30739795918367302</c:v>
                </c:pt>
                <c:pt idx="2">
                  <c:v>0.1211734693877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81F-0549-B8A3-021E12ED3EE6}"/>
            </c:ext>
          </c:extLst>
        </c:ser>
        <c:ser>
          <c:idx val="1"/>
          <c:order val="1"/>
          <c:tx>
            <c:strRef>
              <c:f>'Pie chart serotype distribution'!$I$19</c:f>
              <c:strCache>
                <c:ptCount val="1"/>
                <c:pt idx="0">
                  <c:v>Gunungkidul</c:v>
                </c:pt>
              </c:strCache>
            </c:strRef>
          </c:tx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C81F-0549-B8A3-021E12ED3EE6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C81F-0549-B8A3-021E12ED3EE6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C81F-0549-B8A3-021E12ED3EE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Pie chart serotype distribution'!$J$17:$L$17</c:f>
              <c:strCache>
                <c:ptCount val="3"/>
                <c:pt idx="0">
                  <c:v>Vaccine Serotypes</c:v>
                </c:pt>
                <c:pt idx="1">
                  <c:v>Non-vaccine Serotypes</c:v>
                </c:pt>
                <c:pt idx="2">
                  <c:v>Nontypeable</c:v>
                </c:pt>
              </c:strCache>
            </c:strRef>
          </c:cat>
          <c:val>
            <c:numRef>
              <c:f>'Pie chart serotype distribution'!$J$19:$L$19</c:f>
              <c:numCache>
                <c:formatCode>0.0%</c:formatCode>
                <c:ptCount val="3"/>
                <c:pt idx="0">
                  <c:v>0.476780185758514</c:v>
                </c:pt>
                <c:pt idx="1">
                  <c:v>0.417956656346749</c:v>
                </c:pt>
                <c:pt idx="2">
                  <c:v>0.1052631578947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81F-0549-B8A3-021E12ED3EE6}"/>
            </c:ext>
          </c:extLst>
        </c:ser>
        <c:ser>
          <c:idx val="2"/>
          <c:order val="2"/>
          <c:tx>
            <c:strRef>
              <c:f>'Pie chart serotype distribution'!$I$20</c:f>
              <c:strCache>
                <c:ptCount val="1"/>
                <c:pt idx="0">
                  <c:v>Overall</c:v>
                </c:pt>
              </c:strCache>
            </c:strRef>
          </c:tx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81F-0549-B8A3-021E12ED3EE6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81F-0549-B8A3-021E12ED3EE6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C81F-0549-B8A3-021E12ED3EE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/>
            </c:extLst>
          </c:dLbls>
          <c:cat>
            <c:strRef>
              <c:f>'Pie chart serotype distribution'!$J$17:$L$17</c:f>
              <c:strCache>
                <c:ptCount val="3"/>
                <c:pt idx="0">
                  <c:v>Vaccine Serotypes</c:v>
                </c:pt>
                <c:pt idx="1">
                  <c:v>Non-vaccine Serotypes</c:v>
                </c:pt>
                <c:pt idx="2">
                  <c:v>Nontypeable</c:v>
                </c:pt>
              </c:strCache>
            </c:strRef>
          </c:cat>
          <c:val>
            <c:numRef>
              <c:f>'Pie chart serotype distribution'!$J$20:$L$20</c:f>
              <c:numCache>
                <c:formatCode>0.0%</c:formatCode>
                <c:ptCount val="3"/>
                <c:pt idx="0">
                  <c:v>0.54381210478771402</c:v>
                </c:pt>
                <c:pt idx="1">
                  <c:v>0.339656729900632</c:v>
                </c:pt>
                <c:pt idx="2">
                  <c:v>0.1165311653116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C81F-0549-B8A3-021E12ED3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"/>
      </c:doughnutChart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4947865414298598"/>
          <c:y val="3.9350211929712497E-2"/>
          <c:w val="0.233255930882102"/>
          <c:h val="0.1932266593897090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0074</cdr:x>
      <cdr:y>0.66267</cdr:y>
    </cdr:from>
    <cdr:to>
      <cdr:x>0.28341</cdr:x>
      <cdr:y>0.7314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CA6FD5E8-80B9-4FD2-AF12-42AAF7FCC6A0}"/>
            </a:ext>
          </a:extLst>
        </cdr:cNvPr>
        <cdr:cNvSpPr txBox="1"/>
      </cdr:nvSpPr>
      <cdr:spPr>
        <a:xfrm xmlns:a="http://schemas.openxmlformats.org/drawingml/2006/main">
          <a:off x="914699" y="3235516"/>
          <a:ext cx="1658619" cy="335771"/>
        </a:xfrm>
        <a:prstGeom xmlns:a="http://schemas.openxmlformats.org/drawingml/2006/main" prst="rect">
          <a:avLst/>
        </a:prstGeom>
        <a:ln xmlns:a="http://schemas.openxmlformats.org/drawingml/2006/main" w="6350">
          <a:noFill/>
        </a:ln>
      </cdr:spPr>
      <cdr:style>
        <a:lnRef xmlns:a="http://schemas.openxmlformats.org/drawingml/2006/main" idx="2">
          <a:schemeClr val="dk1"/>
        </a:lnRef>
        <a:fillRef xmlns:a="http://schemas.openxmlformats.org/drawingml/2006/main" idx="1">
          <a:schemeClr val="lt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00"/>
            <a:t>Overall</a:t>
          </a:r>
          <a:r>
            <a:rPr lang="en-US" sz="1000" baseline="0"/>
            <a:t> (N=1,107)</a:t>
          </a:r>
          <a:endParaRPr lang="en-US" sz="1000"/>
        </a:p>
      </cdr:txBody>
    </cdr:sp>
  </cdr:relSizeAnchor>
  <cdr:relSizeAnchor xmlns:cdr="http://schemas.openxmlformats.org/drawingml/2006/chartDrawing">
    <cdr:from>
      <cdr:x>0.76565</cdr:x>
      <cdr:y>0.63651</cdr:y>
    </cdr:from>
    <cdr:to>
      <cdr:x>0.99223</cdr:x>
      <cdr:y>0.7282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F61C3BF0-32DE-48B1-8825-8EBDF9BB693D}"/>
            </a:ext>
          </a:extLst>
        </cdr:cNvPr>
        <cdr:cNvSpPr txBox="1"/>
      </cdr:nvSpPr>
      <cdr:spPr>
        <a:xfrm xmlns:a="http://schemas.openxmlformats.org/drawingml/2006/main">
          <a:off x="6952032" y="3107774"/>
          <a:ext cx="2057316" cy="4476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/>
            <a:t>Southwest Sumba</a:t>
          </a:r>
          <a:r>
            <a:rPr lang="en-US" sz="1000" baseline="0"/>
            <a:t> (N=784)</a:t>
          </a:r>
          <a:endParaRPr lang="en-US" sz="1000"/>
        </a:p>
      </cdr:txBody>
    </cdr:sp>
  </cdr:relSizeAnchor>
  <cdr:relSizeAnchor xmlns:cdr="http://schemas.openxmlformats.org/drawingml/2006/chartDrawing">
    <cdr:from>
      <cdr:x>0.21163</cdr:x>
      <cdr:y>0.05831</cdr:y>
    </cdr:from>
    <cdr:to>
      <cdr:x>0.43821</cdr:x>
      <cdr:y>0.15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:a16="http://schemas.microsoft.com/office/drawing/2014/main" id="{E7948F21-B4BF-4F2C-8EAF-2196F4601DC5}"/>
            </a:ext>
          </a:extLst>
        </cdr:cNvPr>
        <cdr:cNvSpPr txBox="1"/>
      </cdr:nvSpPr>
      <cdr:spPr>
        <a:xfrm xmlns:a="http://schemas.openxmlformats.org/drawingml/2006/main">
          <a:off x="1921604" y="284710"/>
          <a:ext cx="2057316" cy="4476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/>
            <a:t>Gunungkidul </a:t>
          </a:r>
          <a:r>
            <a:rPr lang="en-US" sz="1000" baseline="0"/>
            <a:t>(N=323)</a:t>
          </a:r>
          <a:endParaRPr lang="en-US" sz="1000"/>
        </a:p>
      </cdr:txBody>
    </cdr:sp>
  </cdr:relSizeAnchor>
  <cdr:relSizeAnchor xmlns:cdr="http://schemas.openxmlformats.org/drawingml/2006/chartDrawing">
    <cdr:from>
      <cdr:x>0.19321</cdr:x>
      <cdr:y>0.5997</cdr:y>
    </cdr:from>
    <cdr:to>
      <cdr:x>0.34624</cdr:x>
      <cdr:y>0.66476</cdr:y>
    </cdr:to>
    <cdr:cxnSp macro="">
      <cdr:nvCxnSpPr>
        <cdr:cNvPr id="8" name="Straight Connector 7">
          <a:extLst xmlns:a="http://schemas.openxmlformats.org/drawingml/2006/main">
            <a:ext uri="{FF2B5EF4-FFF2-40B4-BE49-F238E27FC236}">
              <a16:creationId xmlns:a16="http://schemas.microsoft.com/office/drawing/2014/main" id="{C59178E0-A3D7-487F-BB32-1FCBF45B95FF}"/>
            </a:ext>
          </a:extLst>
        </cdr:cNvPr>
        <cdr:cNvCxnSpPr/>
      </cdr:nvCxnSpPr>
      <cdr:spPr>
        <a:xfrm xmlns:a="http://schemas.openxmlformats.org/drawingml/2006/main" flipV="1">
          <a:off x="1047145" y="1590261"/>
          <a:ext cx="829362" cy="172524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216</cdr:x>
      <cdr:y>0.10592</cdr:y>
    </cdr:from>
    <cdr:to>
      <cdr:x>0.43866</cdr:x>
      <cdr:y>0.31484</cdr:y>
    </cdr:to>
    <cdr:cxnSp macro="">
      <cdr:nvCxnSpPr>
        <cdr:cNvPr id="10" name="Straight Connector 9">
          <a:extLst xmlns:a="http://schemas.openxmlformats.org/drawingml/2006/main">
            <a:ext uri="{FF2B5EF4-FFF2-40B4-BE49-F238E27FC236}">
              <a16:creationId xmlns:a16="http://schemas.microsoft.com/office/drawing/2014/main" id="{CBBAD596-FAEE-4694-85DC-C47BD12ED8C8}"/>
            </a:ext>
          </a:extLst>
        </cdr:cNvPr>
        <cdr:cNvCxnSpPr/>
      </cdr:nvCxnSpPr>
      <cdr:spPr>
        <a:xfrm xmlns:a="http://schemas.openxmlformats.org/drawingml/2006/main">
          <a:off x="1800216" y="280874"/>
          <a:ext cx="577224" cy="554013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3425</cdr:x>
      <cdr:y>0.54602</cdr:y>
    </cdr:from>
    <cdr:to>
      <cdr:x>0.76274</cdr:x>
      <cdr:y>0.65792</cdr:y>
    </cdr:to>
    <cdr:cxnSp macro="">
      <cdr:nvCxnSpPr>
        <cdr:cNvPr id="12" name="Straight Connector 11">
          <a:extLst xmlns:a="http://schemas.openxmlformats.org/drawingml/2006/main">
            <a:ext uri="{FF2B5EF4-FFF2-40B4-BE49-F238E27FC236}">
              <a16:creationId xmlns:a16="http://schemas.microsoft.com/office/drawing/2014/main" id="{033D9FA3-5A4F-468C-8BE3-AD66752D2454}"/>
            </a:ext>
          </a:extLst>
        </cdr:cNvPr>
        <cdr:cNvCxnSpPr/>
      </cdr:nvCxnSpPr>
      <cdr:spPr>
        <a:xfrm xmlns:a="http://schemas.openxmlformats.org/drawingml/2006/main">
          <a:off x="4850879" y="2665933"/>
          <a:ext cx="2074707" cy="546394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84DE9-8B3A-892D-DD50-2CB9CFA1CE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978167-DE94-9A4D-1BD2-D901002870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AF3C6-81DE-039F-87F1-990771F98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092AA-6908-2E76-F9D6-2CE5336A9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D3A939-176F-3A49-7D30-CC8DB14D3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155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CAC717-3AF7-66D2-EFB0-3C5BB0DBF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B735D0-F9B2-4D50-2B40-ADD8A1C968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27B91-814D-4DBB-3865-096203B14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F81CE1-4769-7905-8350-53A11FC466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2BB424-7279-D7AD-D28F-65EAF03FB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996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8F6B0F-FA3F-3254-AFBA-E2AC42AD16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7B26BD-624A-1A87-58C4-A16A950E2C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925611-C236-9029-7ADE-D2269FB03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F70914-34F7-E7A3-9FB2-28CFC558C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C389BC-C068-F3D8-9D01-FCC2B0C42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251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A77770-5ADA-7603-5423-605BE3E58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EF9004-7EE2-4FCF-9EC7-7C8ABD4507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D40D3-6293-BC94-AED3-CAC9FC714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25212-4C3A-98A7-1D68-F3CC6C892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A64DA8-7D97-1EB2-8F22-CEAE50AA2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395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1CCEAF-B49F-FA4B-D277-11992D6B8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114DD5-01AB-C47A-D712-FA6BFD1EFE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76D79B-1CB4-E6A3-9BCA-53578A4E2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580381-1843-DF4C-353B-0BC95C1C5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650D31-5609-F554-DD5C-C6A3F71E1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658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9958CB-41E5-D7FC-C5AC-518692B1AB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448030-E522-AB07-3502-F378CF9FB2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F209DC-C71F-70FA-6DA9-9F0BF71E7B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DB3962-9B03-8DED-7473-FB475994F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8AC934-58FD-4003-FF9F-ED38F91B3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025082-7B2C-D709-35A4-ACC83A95F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228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E0463-48C1-A609-4053-3957E7272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80D5AF-1E3B-99E0-300C-825B0489A7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834145-54A2-1510-ABF4-C458ADFF81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05DF28-7E02-287A-D663-AF68D984C9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BA897A-4801-DB5A-BA99-9B41A0B4E2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382014-074E-EF34-02C3-7CF30A58F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119591-C031-0F93-6F3C-73BBF28D6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FF71D99-870F-3445-E160-AD79D3C31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900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3D098-7B4D-82F2-FFC1-EE71312D9B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52514C-EADC-62D6-EE9B-CDF8C383A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1ED55F-3234-ED61-30E0-75FA9E08B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8527FD-F414-596F-F792-F2053326E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6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067E84-B180-BA2F-AD24-4A9FE6AE1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465699-8C53-1B34-F623-F8D432589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AB49EE-3628-FFBC-3641-EC72C66CE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104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15F9F-739C-D2CB-1B43-757AF7D63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4A68A5-C043-8827-7134-7B685D7178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5629F7-E79E-1FBD-B4D8-885E718C40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7F5B45-0060-D019-0CAF-2EB32B7FA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66AFD8-6FA9-491F-4D5E-B09D5C39A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F85CDA-9012-49D6-D8DB-419B78355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486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C86D83-F1B8-8B83-3574-144FBA4D2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F02F53-C7D8-5841-92DE-E731438975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CC538C-27AD-2929-62B1-23844B6E1A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C1C7E9-84D5-1ADB-6015-20E3614E2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1534AB-68D9-B332-AEC7-C068CB601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CB44BE-951D-AC0E-B642-DD9428E36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858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38F11F-1B03-06FB-41BC-9550E823B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7CFB6A-2543-040A-DB0B-8463653AB4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3439BC-B7DE-7F1D-BE90-A6363AFADC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6E222-A37F-144C-A51E-7D9AA375907F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371289-FE12-9AF2-32FA-404CEBA38E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EC3C82-778E-29FC-750C-3953B02424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705B7-320D-2D4F-8D69-CEEF44B50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202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CB49EE3-A5AA-493D-8307-6567BCC33C2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35552751"/>
              </p:ext>
            </p:extLst>
          </p:nvPr>
        </p:nvGraphicFramePr>
        <p:xfrm>
          <a:off x="1298892" y="1173481"/>
          <a:ext cx="9079865" cy="4882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6F26002F-4306-B6A5-7706-6B193ABC692C}"/>
              </a:ext>
            </a:extLst>
          </p:cNvPr>
          <p:cNvSpPr txBox="1"/>
          <p:nvPr/>
        </p:nvSpPr>
        <p:spPr>
          <a:xfrm>
            <a:off x="0" y="5903893"/>
            <a:ext cx="11845528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‘Ns’ are the total number of pneumococcal isolates for each category.</a:t>
            </a:r>
            <a:endParaRPr lang="en-ID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sz="14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ccin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erotypes were those included in PCV13 (1, 3, 4, 5, 6A, 6B, 7F, 9V, 14, 18C, 19A, 19F, and 23F).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. pneumonia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solates were deemed to be non-typeable if a serotype could not be determined by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mPCR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</a:t>
            </a:r>
            <a:r>
              <a:rPr lang="en-US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Quellung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but showed positive results for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ytA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ene. Non-vaccine serotypes were the remaining serotypes (i.e., not included in PCV13 or deemed non-typeable).</a:t>
            </a:r>
            <a:endParaRPr lang="en-ID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2953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6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di Safari</dc:creator>
  <cp:lastModifiedBy>teti novianti</cp:lastModifiedBy>
  <cp:revision>2</cp:revision>
  <dcterms:created xsi:type="dcterms:W3CDTF">2023-07-09T16:11:20Z</dcterms:created>
  <dcterms:modified xsi:type="dcterms:W3CDTF">2024-01-01T12:22:14Z</dcterms:modified>
</cp:coreProperties>
</file>